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216754" y="2681417"/>
            <a:ext cx="5131349" cy="393370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32236" y="6722075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PFS in patients with different tumor cell differentiation.  Log-rank test demonstrated no significant association between PFS and tumor cell differenti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8375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3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7:10Z</dcterms:modified>
</cp:coreProperties>
</file>